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DBB3291-66CD-46AB-B345-0DC9FEFC0EE3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3895A58-E451-493A-AE3B-56EDC78ED449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2"/>
          <p:cNvSpPr/>
          <p:nvPr/>
        </p:nvSpPr>
        <p:spPr>
          <a:xfrm>
            <a:off x="3882960" y="8685360"/>
            <a:ext cx="2962440" cy="44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5D8929E1-D89B-4683-8177-BC44F7DDDD9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"/>
          <p:cNvSpPr/>
          <p:nvPr/>
        </p:nvSpPr>
        <p:spPr>
          <a:xfrm>
            <a:off x="1143000" y="685800"/>
            <a:ext cx="457056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1"/>
          <p:cNvSpPr>
            <a:spLocks noGrp="1"/>
          </p:cNvSpPr>
          <p:nvPr>
            <p:ph type="body"/>
          </p:nvPr>
        </p:nvSpPr>
        <p:spPr>
          <a:xfrm>
            <a:off x="685440" y="4343040"/>
            <a:ext cx="5481720" cy="4205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AD56FB-C69E-4E7B-8198-E59443FE3BB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5ECF0F-8EA7-466D-8774-B5EF280BC0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644094-D817-46C8-9F52-B9FAF69C657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4B7009-A80B-43C0-8588-C1B4E628147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419C61-6C88-48C1-BDF1-5892D782FA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CA51ED-2BD2-4401-B8ED-7ED3DB295B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BD3A8B-8820-46C9-941D-BBDA9E6E158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25DD80-3702-4BDA-9B63-88491D296A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D6EC14-E2AD-40BD-9E48-01CBD74AFD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CAA4E3-1779-4EB4-AE06-FD37192BF1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C39BE7-D0E9-4CA9-B694-7E6774D2E7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99B961-2794-4489-A61B-3B5623C4D3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E3CBF6F-79AF-4661-85F5-75DA069347B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3"/>
          <p:cNvSpPr/>
          <p:nvPr/>
        </p:nvSpPr>
        <p:spPr>
          <a:xfrm>
            <a:off x="684360" y="5524560"/>
            <a:ext cx="806436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Figure S3. Analysis of the Ib component of iota toxin that is putatively produced by the PB-1 strain. 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Upper portion shows putative functional regions.</a:t>
            </a:r>
            <a:r>
              <a:rPr b="0" lang="ja-JP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Lower portion shows comparison of deduced amino acid sequence among iota toxin Ib component on pCPPB-1, Ib component in </a:t>
            </a:r>
            <a:r>
              <a:rPr b="0" i="1" lang="ja-JP" sz="1400" spc="-1" strike="noStrike">
                <a:solidFill>
                  <a:srgbClr val="000000"/>
                </a:solidFill>
                <a:latin typeface="Arial"/>
              </a:rPr>
              <a:t>C. perfringens 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type E strain (JGS1987), and the CdtB binding component of CDT in </a:t>
            </a:r>
            <a:r>
              <a:rPr b="0" i="1" lang="ja-JP" sz="1400" spc="-1" strike="noStrike">
                <a:solidFill>
                  <a:srgbClr val="000000"/>
                </a:solidFill>
                <a:latin typeface="Arial"/>
              </a:rPr>
              <a:t>C. difficile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1"/>
          <a:stretch/>
        </p:blipFill>
        <p:spPr>
          <a:xfrm>
            <a:off x="684360" y="301680"/>
            <a:ext cx="7127640" cy="606240"/>
          </a:xfrm>
          <a:prstGeom prst="rect">
            <a:avLst/>
          </a:prstGeom>
          <a:ln w="0">
            <a:noFill/>
          </a:ln>
        </p:spPr>
      </p:pic>
      <p:pic>
        <p:nvPicPr>
          <p:cNvPr id="50" name="" descr=""/>
          <p:cNvPicPr/>
          <p:nvPr/>
        </p:nvPicPr>
        <p:blipFill>
          <a:blip r:embed="rId2"/>
          <a:stretch/>
        </p:blipFill>
        <p:spPr>
          <a:xfrm>
            <a:off x="826920" y="1038240"/>
            <a:ext cx="5616720" cy="4478400"/>
          </a:xfrm>
          <a:prstGeom prst="rect">
            <a:avLst/>
          </a:prstGeom>
          <a:ln w="0">
            <a:noFill/>
          </a:ln>
        </p:spPr>
      </p:pic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04T00:01:52Z</dcterms:created>
  <dc:creator>MIYAMOTO</dc:creator>
  <dc:description/>
  <dc:language>en-US</dc:language>
  <cp:lastModifiedBy>MIYAMOTO</cp:lastModifiedBy>
  <dcterms:modified xsi:type="dcterms:W3CDTF">2011-05-04T00:03:04Z</dcterms:modified>
  <cp:revision>3</cp:revision>
  <dc:subject/>
  <dc:title>スライド 1</dc:title>
</cp:coreProperties>
</file>